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_rels/presentation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70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</p:sldMasterIdLst>
  <p:sldIdLst>
    <p:sldId id="256" r:id="rId9"/>
  </p:sldIdLst>
  <p:sldSz cx="9144000" cy="6858000"/>
  <p:notesSz cx="6807200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" Target="slides/slide1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A3832-ECFD-4091-BD7D-B0AF85A613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4EDFC-A156-45D5-A10F-2A1A234677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9B02D-C179-4825-B4C3-E6F36B9D7E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F9AE46-84FC-43B0-BEAD-398797AF4B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66895B-FC85-4781-BBE7-4B65DF99F9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23DB22-92BC-4D9F-B4EE-3B2CE9D441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3C053B8-D732-492A-933B-8BFA6E213B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D4A29B8-B5DA-4A5F-B351-24E82CFC83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CB8E661-542E-43F9-A778-19D9E584F6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00760E5-A301-4D55-BF0A-D3A695604F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E74083-4DBC-4FB1-A3A1-93CAD3AC9C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B59D1-5647-49EB-8B04-CF7F19FACB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3F71208-87CF-4F81-B1D6-639A1AE0D7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FFD441A-C8FF-453A-AAD7-4AB6A44521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EAD1908-7050-467B-B094-C1FFA2963C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C6D4BD-91AA-4CCF-82BE-E4FB032BE0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559AA35-368B-47C2-828E-D1529C955F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0CF0BFD-D7E4-4FDD-B4F4-422EDEB991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DD927EC-2AC4-4C91-A148-C6546EDA61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EBBF282-1D78-48D4-9BD8-680AD0CD0D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2242444-6BA3-4C3A-8467-E7EDF27822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21FC32F-57CB-4F08-B9D6-94F4C95127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F41F2-B89B-458B-BEA7-371351435E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3EE8548-4224-45BB-B818-A58E676AA1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E84ACA2-8DE4-4968-854C-5187C89E11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7CA00AE-5809-4A32-BA1E-24A562C96D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8EA0136-AC25-4DF1-B1EE-846F1AB89F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16CA9F7-EA9C-491A-962B-4DC1508226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BC56ED1-837E-41B4-B478-9F462D79BD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944728D-C42A-43F5-A5FC-C2AAD2D5AC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DF30AC6-81FA-4032-B4AD-A485A5BF17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11978BC-DABF-4EC9-920E-F983947A85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D844848-0489-4A43-AAAF-72EBFCEF79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9A9DDE-CE5B-40A3-B479-6B637CB2E2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20FAAAD-226E-4BED-9D19-8972F4D813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2E4EA5A-5248-4C1E-AA29-33AE172B7E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D9054F8-5164-4E49-A0C6-EB2A1EABD2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24364E9-DCB9-42EC-8478-1EBAB96777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E2E9121-3FC2-4844-9FBD-F4324442E1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8A8193C-6387-4266-9E12-1D4A945368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57EACC3-C254-4D81-9FEC-CC873C45F7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DD3C61B-4BF2-47E6-9AA8-FAB80C8E32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9ED5F69-CE10-4157-8281-9176E41CE3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0CE6B09-18A2-4967-B899-E9F6B6C112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E29DC-A171-4494-94E7-79480313B5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3CC97E2-5357-427C-A58A-183B818C7C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06BDC59-ADD5-433D-883E-8A2BF5449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798BA1F-E241-445E-ABA4-6A25A1F5C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1A65E81-8F97-48F2-B295-9E6F2D80BA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D30EE08-7AE7-4B5A-B271-EA7B883251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FEDFA9D-6C29-4108-B0DA-B473385005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B5BE293-1958-47A1-B2A2-25203A93E0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0F5BC42-BF43-404F-8112-2CE8B9185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8C5F091-9271-4307-B6A5-55D6F49CBE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4081D10-0E54-4B7B-941C-70F28A74A9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5C38F-CDE4-477C-934C-33447E6C88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6182727-107E-4AA1-BD3D-C1306286C0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953EE38-DFEE-4859-91DD-5ABCF66C7F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3390FAA-4FE3-4DD3-AA6C-8F2E08CE58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478E2F1-5AC6-45F8-9346-DB71C89363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2672136-FA37-4008-B882-FB7BDFF4B2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28D0D60-56F3-455F-86BD-404B93460B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9109F81-5961-4B14-B414-F370D2871B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55A3777-541F-420D-85BB-420E9EC789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E48CC0A-743B-4373-8FF2-826185FBA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0690168-9F2F-43E2-A7DC-2A1D12C4F7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97CE78-A3C3-4F99-897F-AFEAA2A747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B7DD6BF-7FAA-4F4B-A590-D80CFF7E4C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B13EE14-FEEF-4B3B-BFCE-6CCFD66D31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8029688-DD3C-43B1-B459-9B47AD2469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6AAB2CD-6163-47CC-A3E1-6A62635A33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44760BC-AA42-445C-A111-B3BF22BAC2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E10ED95-58D3-4A40-9829-A651C5D4C3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47E3233-FCA8-41C6-973F-EC39A182E2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06E7221-DA2C-45ED-8208-29FD342F2D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24760AA-00AC-4DA5-8940-9518144519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75420B1-8432-4C67-B4FA-BEC8BC99A3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42843-A213-4EB8-8BD9-BB081B6B4E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0FC10F4-2244-4ED3-BBBA-38603382A7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167FF0C-A8D5-44DD-AF4C-BA9AD3CF13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2007C61-A387-45C1-9630-97291555B8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5AB18D7-4D8D-4B23-87CA-6D1187B6DA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DE15CC6-A18E-44EE-8459-B05A1B99B7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283B7-16AB-469C-A3B3-DADEF7DECE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E5382F-E165-41B9-9665-ACF9F352213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E9C8A6-9A2D-4700-B97F-0576707007F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9EBBB5-6A1C-44EF-87E4-0E7DD6FC0CEE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Osak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1CECFF-6606-4ED7-AE94-9F2498078CF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ECDBB4-3919-4D5F-B488-C8A6E69FB56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Osaka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5A486C-780E-47F1-8C04-719C64A4B4F0}" type="slidenum">
              <a:rPr b="0" lang="en-US" sz="1400" spc="-1" strike="noStrike">
                <a:solidFill>
                  <a:srgbClr val="000000"/>
                </a:solidFill>
                <a:latin typeface="Arial"/>
                <a:ea typeface="Osaka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15421C-BD8B-4131-A6C1-BBBFF8FFC78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テキスト ボックス 1"/>
          <p:cNvSpPr/>
          <p:nvPr/>
        </p:nvSpPr>
        <p:spPr>
          <a:xfrm>
            <a:off x="3983040" y="617400"/>
            <a:ext cx="1687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R702C heter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テキスト ボックス 2"/>
          <p:cNvSpPr/>
          <p:nvPr/>
        </p:nvSpPr>
        <p:spPr>
          <a:xfrm>
            <a:off x="2035080" y="725400"/>
            <a:ext cx="212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702C+/-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直線コネクタ 4"/>
          <p:cNvSpPr/>
          <p:nvPr/>
        </p:nvSpPr>
        <p:spPr>
          <a:xfrm>
            <a:off x="582480" y="1204920"/>
            <a:ext cx="7712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テキスト ボックス 6"/>
          <p:cNvSpPr/>
          <p:nvPr/>
        </p:nvSpPr>
        <p:spPr>
          <a:xfrm>
            <a:off x="9360" y="14940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let coun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テキスト ボックス 8"/>
          <p:cNvSpPr/>
          <p:nvPr/>
        </p:nvSpPr>
        <p:spPr>
          <a:xfrm>
            <a:off x="2766960" y="1494000"/>
            <a:ext cx="66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2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テキスト ボックス 11"/>
          <p:cNvSpPr/>
          <p:nvPr/>
        </p:nvSpPr>
        <p:spPr>
          <a:xfrm>
            <a:off x="2798640" y="2413080"/>
            <a:ext cx="60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.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テキスト ボックス 12"/>
          <p:cNvSpPr/>
          <p:nvPr/>
        </p:nvSpPr>
        <p:spPr>
          <a:xfrm>
            <a:off x="9360" y="24130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latelet diamete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テキスト ボックス 13"/>
          <p:cNvSpPr/>
          <p:nvPr/>
        </p:nvSpPr>
        <p:spPr>
          <a:xfrm>
            <a:off x="4494240" y="241308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テキスト ボックス 1"/>
          <p:cNvSpPr/>
          <p:nvPr/>
        </p:nvSpPr>
        <p:spPr>
          <a:xfrm>
            <a:off x="34920" y="3390840"/>
            <a:ext cx="227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buminuri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テキスト ボックス 14"/>
          <p:cNvSpPr/>
          <p:nvPr/>
        </p:nvSpPr>
        <p:spPr>
          <a:xfrm>
            <a:off x="2733840" y="3390840"/>
            <a:ext cx="73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2.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テキスト ボックス 15"/>
          <p:cNvSpPr/>
          <p:nvPr/>
        </p:nvSpPr>
        <p:spPr>
          <a:xfrm>
            <a:off x="3898800" y="3390840"/>
            <a:ext cx="1857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round 1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テキスト ボックス 8"/>
          <p:cNvSpPr/>
          <p:nvPr/>
        </p:nvSpPr>
        <p:spPr>
          <a:xfrm>
            <a:off x="4494240" y="149400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直線コネクタ 17"/>
          <p:cNvSpPr/>
          <p:nvPr/>
        </p:nvSpPr>
        <p:spPr>
          <a:xfrm>
            <a:off x="582480" y="5030640"/>
            <a:ext cx="77122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テキスト ボックス 23"/>
          <p:cNvSpPr/>
          <p:nvPr/>
        </p:nvSpPr>
        <p:spPr>
          <a:xfrm>
            <a:off x="442800" y="5165640"/>
            <a:ext cx="814068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ta for GFP-R702C hetero mice, D1424N hetero mice and E1841K hetero mice originated from [14]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ese data are represented by mean/mean (R702C+/- mice/WT mice or GFP-R702C hetero mice or D1424N hetero mice or E1841K hetero mice /WT mice).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テキスト ボックス 1"/>
          <p:cNvSpPr/>
          <p:nvPr/>
        </p:nvSpPr>
        <p:spPr>
          <a:xfrm>
            <a:off x="2228760" y="3710160"/>
            <a:ext cx="173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20 weeks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テキスト ボックス 1"/>
          <p:cNvSpPr/>
          <p:nvPr/>
        </p:nvSpPr>
        <p:spPr>
          <a:xfrm>
            <a:off x="131760" y="4475160"/>
            <a:ext cx="2082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eafnes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テキスト ボックス 3"/>
          <p:cNvSpPr/>
          <p:nvPr/>
        </p:nvSpPr>
        <p:spPr>
          <a:xfrm>
            <a:off x="2773440" y="4475160"/>
            <a:ext cx="65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テキスト ボックス 22"/>
          <p:cNvSpPr/>
          <p:nvPr/>
        </p:nvSpPr>
        <p:spPr>
          <a:xfrm>
            <a:off x="4503600" y="4475160"/>
            <a:ext cx="64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テキスト ボックス 5"/>
          <p:cNvSpPr/>
          <p:nvPr/>
        </p:nvSpPr>
        <p:spPr>
          <a:xfrm>
            <a:off x="639720" y="371016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ag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テキスト ボックス 25"/>
          <p:cNvSpPr/>
          <p:nvPr/>
        </p:nvSpPr>
        <p:spPr>
          <a:xfrm>
            <a:off x="3957480" y="3710160"/>
            <a:ext cx="173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unknow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テキスト ボックス 1"/>
          <p:cNvSpPr/>
          <p:nvPr/>
        </p:nvSpPr>
        <p:spPr>
          <a:xfrm>
            <a:off x="5643720" y="617400"/>
            <a:ext cx="1211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1424N heter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テキスト ボックス 1"/>
          <p:cNvSpPr/>
          <p:nvPr/>
        </p:nvSpPr>
        <p:spPr>
          <a:xfrm>
            <a:off x="7115040" y="617400"/>
            <a:ext cx="12114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1841K heter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テキスト ボックス 8"/>
          <p:cNvSpPr/>
          <p:nvPr/>
        </p:nvSpPr>
        <p:spPr>
          <a:xfrm>
            <a:off x="5916600" y="149400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7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テキスト ボックス 8"/>
          <p:cNvSpPr/>
          <p:nvPr/>
        </p:nvSpPr>
        <p:spPr>
          <a:xfrm>
            <a:off x="7388280" y="149400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.8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テキスト ボックス 13"/>
          <p:cNvSpPr/>
          <p:nvPr/>
        </p:nvSpPr>
        <p:spPr>
          <a:xfrm>
            <a:off x="5916600" y="241308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テキスト ボックス 13"/>
          <p:cNvSpPr/>
          <p:nvPr/>
        </p:nvSpPr>
        <p:spPr>
          <a:xfrm>
            <a:off x="7388280" y="2413080"/>
            <a:ext cx="66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テキスト ボックス 15"/>
          <p:cNvSpPr/>
          <p:nvPr/>
        </p:nvSpPr>
        <p:spPr>
          <a:xfrm>
            <a:off x="5321160" y="3390840"/>
            <a:ext cx="1857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round 2.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テキスト ボックス 15"/>
          <p:cNvSpPr/>
          <p:nvPr/>
        </p:nvSpPr>
        <p:spPr>
          <a:xfrm>
            <a:off x="6791400" y="3390840"/>
            <a:ext cx="185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round 1.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テキスト ボックス 22"/>
          <p:cNvSpPr/>
          <p:nvPr/>
        </p:nvSpPr>
        <p:spPr>
          <a:xfrm>
            <a:off x="5925960" y="4475160"/>
            <a:ext cx="64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テキスト ボックス 22"/>
          <p:cNvSpPr/>
          <p:nvPr/>
        </p:nvSpPr>
        <p:spPr>
          <a:xfrm>
            <a:off x="7396200" y="4475160"/>
            <a:ext cx="6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テキスト ボックス 25"/>
          <p:cNvSpPr/>
          <p:nvPr/>
        </p:nvSpPr>
        <p:spPr>
          <a:xfrm>
            <a:off x="5380200" y="3710160"/>
            <a:ext cx="173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unknow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テキスト ボックス 25"/>
          <p:cNvSpPr/>
          <p:nvPr/>
        </p:nvSpPr>
        <p:spPr>
          <a:xfrm>
            <a:off x="6850080" y="3710160"/>
            <a:ext cx="1739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unknow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8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8T09:37:26Z</dcterms:created>
  <dc:creator>鈴木伸明</dc:creator>
  <dc:description/>
  <dc:language>en-US</dc:language>
  <cp:lastModifiedBy>鈴木伸明</cp:lastModifiedBy>
  <dcterms:modified xsi:type="dcterms:W3CDTF">2013-07-12T11:20:11Z</dcterms:modified>
  <cp:revision>216</cp:revision>
  <dc:subject/>
  <dc:title>PowerPoint プレゼンテーション</dc:title>
</cp:coreProperties>
</file>